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B348904-71A9-42B3-A198-DF65E89CEAF7}" v="4" dt="2026-01-13T19:21:05.8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IMONA MARIANNA SANZANI" userId="97bf332e-2246-47a8-809e-554e4fe727cd" providerId="ADAL" clId="{9CD60A01-E46B-440F-BDE7-2EB3B620E829}"/>
    <pc:docChg chg="custSel modSld">
      <pc:chgData name="SIMONA MARIANNA SANZANI" userId="97bf332e-2246-47a8-809e-554e4fe727cd" providerId="ADAL" clId="{9CD60A01-E46B-440F-BDE7-2EB3B620E829}" dt="2026-01-13T19:21:05.852" v="92" actId="164"/>
      <pc:docMkLst>
        <pc:docMk/>
      </pc:docMkLst>
      <pc:sldChg chg="addSp modSp mod">
        <pc:chgData name="SIMONA MARIANNA SANZANI" userId="97bf332e-2246-47a8-809e-554e4fe727cd" providerId="ADAL" clId="{9CD60A01-E46B-440F-BDE7-2EB3B620E829}" dt="2026-01-13T19:21:05.852" v="92" actId="164"/>
        <pc:sldMkLst>
          <pc:docMk/>
          <pc:sldMk cId="3857038420" sldId="256"/>
        </pc:sldMkLst>
        <pc:spChg chg="add mod">
          <ac:chgData name="SIMONA MARIANNA SANZANI" userId="97bf332e-2246-47a8-809e-554e4fe727cd" providerId="ADAL" clId="{9CD60A01-E46B-440F-BDE7-2EB3B620E829}" dt="2026-01-13T19:21:05.852" v="92" actId="164"/>
          <ac:spMkLst>
            <pc:docMk/>
            <pc:sldMk cId="3857038420" sldId="256"/>
            <ac:spMk id="2" creationId="{C240457C-9896-99F4-5630-0788079031E5}"/>
          </ac:spMkLst>
        </pc:spChg>
        <pc:grpChg chg="add mod">
          <ac:chgData name="SIMONA MARIANNA SANZANI" userId="97bf332e-2246-47a8-809e-554e4fe727cd" providerId="ADAL" clId="{9CD60A01-E46B-440F-BDE7-2EB3B620E829}" dt="2026-01-13T19:21:05.852" v="92" actId="164"/>
          <ac:grpSpMkLst>
            <pc:docMk/>
            <pc:sldMk cId="3857038420" sldId="256"/>
            <ac:grpSpMk id="3" creationId="{0D395418-5BDD-BD39-5107-78304280EB10}"/>
          </ac:grpSpMkLst>
        </pc:grpChg>
        <pc:picChg chg="mod">
          <ac:chgData name="SIMONA MARIANNA SANZANI" userId="97bf332e-2246-47a8-809e-554e4fe727cd" providerId="ADAL" clId="{9CD60A01-E46B-440F-BDE7-2EB3B620E829}" dt="2026-01-13T19:21:05.852" v="92" actId="164"/>
          <ac:picMkLst>
            <pc:docMk/>
            <pc:sldMk cId="3857038420" sldId="256"/>
            <ac:picMk id="6" creationId="{BC705238-7625-C57F-2230-346AAF58ADB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F377D5-183D-37AE-701F-2B090CC51E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E1415844-B245-BD52-0604-05A3C3F46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6FB7F35-65B8-A831-7F4D-B272A3B4DC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8276AA3-6D86-2834-AD3A-AC36F03A0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399E1B2-BA2E-72CA-F481-A662E03286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2180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CB4C6E8-9E4C-620A-B512-DFF4C7A52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67211A9-429A-2E36-D32B-5C12EDF087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33FAD3B-2A52-34DC-28BB-F65E451A3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41224BD-9DF2-BDE1-E186-0D9F9ED54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C21F894-C242-88B3-4659-A14BE2A68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2140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E5D7A81-B935-D023-F06C-697ECA50A0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48DB3AE-0A3A-8350-E435-C5404B23F0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A1C1259-236E-BDC9-2543-26EBD8627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78CA44C-CC91-AEC8-0890-A5BC99B7D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74C45FD-6FE9-223F-EBF7-31F34D57F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0192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61B3605-2BB9-3746-3B8B-E3174D6686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C8BA5F-7FA5-18CD-8255-409AEE6FFB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F28D3D0-A11F-F9F3-FC50-350B96D15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506D2AC-2810-3B13-029B-7B30BDCBD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A3DE79B-A144-75E0-C2E6-5FAC0DF49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1420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2FCAF35-CD61-3DFB-6F5D-78CCAC88C5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411B608-E66C-1F31-0BD8-648324E6DB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C8D4063-3292-523F-6573-0F1E90998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8C2E932-935F-2CB2-6951-B28166B7B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0A3B2B5-6DE4-D1E4-5F2B-3FC38978C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3654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C69A7EB-2D06-412D-D0A3-A1A10ADC74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8C8D822-A9F2-2D86-2378-BC6EAD3C71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3783A55-05D0-C375-DBB9-37E7C2A440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0FBCC76-23A0-42A9-9AED-0ADB29B53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6659A63-B1CA-41B2-6627-1EB887FE7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C2BE5EC-70DE-B038-13D1-324DAD1E1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2598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F7C301-28AD-9ACA-51D2-6D11EC24D0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4C19785-3362-344E-1ACB-26ADAFA61F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719B5A0-E67E-8985-F867-FE7ABEECC3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FED6E6C-1A65-B808-DFF6-5345713D8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ADCC577-2805-97A9-51F8-858F01F092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7A00DF4-19EF-0283-D790-3530937EE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E79A6FAE-5CF4-2667-D3F7-62A56D420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A8C1286-31F1-AA5A-43CE-DB304474C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1086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28E393A-E1B7-8227-73D8-9AEA35B8B2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9A09797-BC66-3B81-65C9-0536A3CB5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FD0B611-02FD-D85D-1D51-016046E00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38A72D0-D122-F580-7621-2FB02D14A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8234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2C565219-FEB3-B560-93C8-C94398F94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03926A2-FEA4-FCEC-6302-4A61BAB2D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6739B21-4BC6-FA83-577B-B103172C4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9878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28388D-FF39-FA67-CA2A-2947F1631A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FA67266-F1DE-5720-7E99-78837014A1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199860B-4863-41C6-8A04-17363DFE2B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D6500A1-568B-D181-BA97-D7C06078F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40B5600-CC33-65DB-3CAB-F0207F4FC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C56D19E-AFA8-AE22-B487-929214FEBE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2551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7A57CF-35D4-3CC1-5220-FE19B0E4CB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EF23FB03-C1CA-17AC-72B0-EA9F2D81FF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D02145C-66D8-312D-EB79-FBDCBAB42B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F1B8E8D-2B40-EDAE-706F-1A49B737E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243C7FF-70F1-DCA2-DD34-07B15CACA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A110F12-5EF6-1F31-A3BC-262CF70C2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847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BBFAEE0-EFC6-8BD3-B20A-F8897A5D3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C63525F-5379-B450-E285-34F7DDE6D0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F7B60A1-25ED-2257-63C0-2E147A0E65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42CED19-284D-4CAA-94B4-1F6DC899893C}" type="datetimeFigureOut">
              <a:rPr lang="it-IT" smtClean="0"/>
              <a:t>13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E055E0F-699A-9CD0-6D24-8AA6E7073B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20CB69A-0696-7740-CB3F-2E72EBAFDF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6CFA62-650B-49EF-9060-9685A2C51A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8420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C118678-CB05-154B-ABE5-1B99E9D1864F}"/>
              </a:ext>
            </a:extLst>
          </p:cNvPr>
          <p:cNvSpPr txBox="1"/>
          <p:nvPr/>
        </p:nvSpPr>
        <p:spPr>
          <a:xfrm>
            <a:off x="1427939" y="5939135"/>
            <a:ext cx="989728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buNone/>
            </a:pPr>
            <a:r>
              <a:rPr lang="en-US" sz="1800" dirty="0">
                <a:effectLst/>
                <a:latin typeface="Segoe UI" panose="020B0502040204020203" pitchFamily="34" charset="0"/>
              </a:rPr>
              <a:t>Figure S1. Two-dimensional principal component plot of RNA-Seq data from </a:t>
            </a:r>
            <a:r>
              <a:rPr lang="en-US" sz="1800" i="1" dirty="0">
                <a:effectLst/>
                <a:latin typeface="Segoe UI" panose="020B0502040204020203" pitchFamily="34" charset="0"/>
              </a:rPr>
              <a:t>Vitis vinifera</a:t>
            </a:r>
            <a:r>
              <a:rPr lang="en-US" sz="1800" dirty="0">
                <a:effectLst/>
                <a:latin typeface="Segoe UI" panose="020B0502040204020203" pitchFamily="34" charset="0"/>
              </a:rPr>
              <a:t> treated (TRD) or untreated (CTR) by </a:t>
            </a:r>
            <a:r>
              <a:rPr lang="en-US" sz="1800" dirty="0" err="1">
                <a:effectLst/>
                <a:latin typeface="Segoe UI" panose="020B0502040204020203" pitchFamily="34" charset="0"/>
              </a:rPr>
              <a:t>biostimulant</a:t>
            </a:r>
            <a:r>
              <a:rPr lang="en-US" sz="1800" dirty="0">
                <a:effectLst/>
                <a:latin typeface="Segoe UI" panose="020B0502040204020203" pitchFamily="34" charset="0"/>
              </a:rPr>
              <a:t> at 6 and 24 HPT</a:t>
            </a:r>
            <a:endParaRPr lang="en-US" sz="2000" dirty="0">
              <a:effectLst/>
              <a:latin typeface="Arial" panose="020B0604020202020204" pitchFamily="34" charset="0"/>
            </a:endParaRP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0D395418-5BDD-BD39-5107-78304280EB10}"/>
              </a:ext>
            </a:extLst>
          </p:cNvPr>
          <p:cNvGrpSpPr/>
          <p:nvPr/>
        </p:nvGrpSpPr>
        <p:grpSpPr>
          <a:xfrm>
            <a:off x="2697739" y="161925"/>
            <a:ext cx="7422840" cy="5777210"/>
            <a:chOff x="2697739" y="161925"/>
            <a:chExt cx="7422840" cy="5777210"/>
          </a:xfrm>
        </p:grpSpPr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BC705238-7625-C57F-2230-346AAF58AD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97739" y="161925"/>
              <a:ext cx="7422840" cy="5777210"/>
            </a:xfrm>
            <a:prstGeom prst="rect">
              <a:avLst/>
            </a:prstGeom>
          </p:spPr>
        </p:pic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C240457C-9896-99F4-5630-0788079031E5}"/>
                </a:ext>
              </a:extLst>
            </p:cNvPr>
            <p:cNvSpPr txBox="1"/>
            <p:nvPr/>
          </p:nvSpPr>
          <p:spPr>
            <a:xfrm>
              <a:off x="7717536" y="768096"/>
              <a:ext cx="86868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sz="700" dirty="0"/>
                <a:t>× 6 </a:t>
              </a:r>
              <a:r>
                <a:rPr lang="it-IT" sz="700" dirty="0" err="1"/>
                <a:t>hpt</a:t>
              </a:r>
              <a:r>
                <a:rPr lang="it-IT" sz="700" dirty="0"/>
                <a:t>    + 24hp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570384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4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egoe UI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MONA MARIANNA SANZANI</dc:creator>
  <cp:lastModifiedBy>SIMONA MARIANNA SANZANI</cp:lastModifiedBy>
  <cp:revision>1</cp:revision>
  <dcterms:created xsi:type="dcterms:W3CDTF">2026-01-13T10:54:31Z</dcterms:created>
  <dcterms:modified xsi:type="dcterms:W3CDTF">2026-01-13T19:21:05Z</dcterms:modified>
</cp:coreProperties>
</file>